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63" r:id="rId8"/>
    <p:sldId id="264" r:id="rId9"/>
    <p:sldId id="271" r:id="rId10"/>
    <p:sldId id="266" r:id="rId11"/>
    <p:sldId id="267" r:id="rId12"/>
    <p:sldId id="265" r:id="rId13"/>
    <p:sldId id="272" r:id="rId14"/>
    <p:sldId id="269" r:id="rId15"/>
    <p:sldId id="270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53" d="100"/>
          <a:sy n="53" d="100"/>
        </p:scale>
        <p:origin x="34" y="41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handoutMaster" Target="handoutMasters/handoutMaster1.xml"/><Relationship Id="rId3" Type="http://schemas.openxmlformats.org/officeDocument/2006/relationships/slideMaster" Target="slideMasters/slideMaster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30/10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30/10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bostonscientific.com/content/dam/bostonscientific/quality/education-resources/english/PU_Shock_Lead_Impedance_Testing_20110804.pdf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High voltage impedance rise; mechanism and management in patients with transvenous implantable cardioverter defibrillators. A case series.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August 2019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Learning Point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50" y="1475623"/>
            <a:ext cx="2206800" cy="2916377"/>
          </a:xfrm>
        </p:spPr>
        <p:txBody>
          <a:bodyPr>
            <a:normAutofit/>
          </a:bodyPr>
          <a:lstStyle/>
          <a:p>
            <a:r>
              <a:rPr lang="en-GB" dirty="0"/>
              <a:t>Gradual rise in ICD shock impedance can be caused by encapsulation fibrosis; this may be seen in isolation and in the absence of electrical failure.</a:t>
            </a:r>
          </a:p>
          <a:p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43336" y="1475623"/>
            <a:ext cx="2206800" cy="2916377"/>
          </a:xfrm>
        </p:spPr>
        <p:txBody>
          <a:bodyPr>
            <a:normAutofit/>
          </a:bodyPr>
          <a:lstStyle/>
          <a:p>
            <a:r>
              <a:rPr lang="en-GB" dirty="0"/>
              <a:t>Synchronised shock through the device can be used to determine whether a true lead integrity issue exists and requires replacement. </a:t>
            </a:r>
          </a:p>
          <a:p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65377" y="1475623"/>
            <a:ext cx="2206800" cy="2916377"/>
          </a:xfrm>
        </p:spPr>
        <p:txBody>
          <a:bodyPr>
            <a:normAutofit fontScale="92500"/>
          </a:bodyPr>
          <a:lstStyle/>
          <a:p>
            <a:r>
              <a:rPr lang="en-GB" dirty="0"/>
              <a:t>Low voltage subthreshold measurements may be deceptive and small changes to true impedance can be amplified. Only a true shock impedance can give an accurate impedance reading.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lnSpcReduction="10000"/>
          </a:bodyPr>
          <a:lstStyle/>
          <a:p>
            <a:r>
              <a:rPr lang="en-GB" dirty="0"/>
              <a:t>1. Scientific B. Shock Lead Impedance Testing: Boston Scientific; 2011 [Available from: </a:t>
            </a:r>
            <a:r>
              <a:rPr lang="en-GB" u="sng" dirty="0">
                <a:hlinkClick r:id="rId2"/>
              </a:rPr>
              <a:t>https://www.bostonscientific.com/content/dam/bostonscientific/quality/education-resources/english/PU_Shock_Lead_Impedance_Testing_20110804.pdf</a:t>
            </a:r>
            <a:r>
              <a:rPr lang="en-GB" dirty="0"/>
              <a:t>.</a:t>
            </a:r>
          </a:p>
          <a:p>
            <a:r>
              <a:rPr lang="en-GB" dirty="0"/>
              <a:t>2. 19. Weiner S, </a:t>
            </a:r>
            <a:r>
              <a:rPr lang="en-GB" dirty="0" err="1"/>
              <a:t>Coffeen</a:t>
            </a:r>
            <a:r>
              <a:rPr lang="en-GB" dirty="0"/>
              <a:t> P, Kessler D, Mullin C, Merkel S, Chase K. Abstract 3257: Electrical Performance of GORE-Covered Defibrillation Leads is Equivalent to Non-GORE Leads. Circulation. 2006;114(</a:t>
            </a:r>
            <a:r>
              <a:rPr lang="en-GB" dirty="0" err="1"/>
              <a:t>Suppl</a:t>
            </a:r>
            <a:r>
              <a:rPr lang="en-GB" dirty="0"/>
              <a:t> 18):II_690.impedance. Journal of </a:t>
            </a:r>
            <a:r>
              <a:rPr lang="en-GB" dirty="0" err="1"/>
              <a:t>Electrocardiology</a:t>
            </a:r>
            <a:r>
              <a:rPr lang="en-GB" dirty="0"/>
              <a:t>. 2013;46(6):660-2.</a:t>
            </a: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r>
              <a:rPr lang="en-GB" dirty="0"/>
              <a:t>Effective defibrillation requires sufficient current to reset the cardiac action potentials of a critical number of myocardial cells. </a:t>
            </a:r>
          </a:p>
          <a:p>
            <a:r>
              <a:rPr lang="en-GB" dirty="0"/>
              <a:t>A high defibrillation impedance will have greater resistance to current flow and defibrillation may be unsuccessful.</a:t>
            </a:r>
          </a:p>
          <a:p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GB" dirty="0"/>
              <a:t>We present a case series of patients implanted with Boston Scientific ICDs, all of whom exhibited a significant, gradual rise in defibrillation (HV) impedance above the upper limit of normality. 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171520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/>
              <a:t>Case Presentations Summary Table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6BF47595-F87E-45FB-AF2E-7947DABD21FE}"/>
              </a:ext>
            </a:extLst>
          </p:cNvPr>
          <p:cNvGraphicFramePr>
            <a:graphicFrameLocks noGrp="1"/>
          </p:cNvGraphicFramePr>
          <p:nvPr>
            <p:ph sz="quarter" idx="13"/>
            <p:extLst>
              <p:ext uri="{D42A27DB-BD31-4B8C-83A1-F6EECF244321}">
                <p14:modId xmlns:p14="http://schemas.microsoft.com/office/powerpoint/2010/main" val="3750537514"/>
              </p:ext>
            </p:extLst>
          </p:nvPr>
        </p:nvGraphicFramePr>
        <p:xfrm>
          <a:off x="324000" y="1028770"/>
          <a:ext cx="8294400" cy="360181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81848">
                  <a:extLst>
                    <a:ext uri="{9D8B030D-6E8A-4147-A177-3AD203B41FA5}">
                      <a16:colId xmlns:a16="http://schemas.microsoft.com/office/drawing/2014/main" val="429228238"/>
                    </a:ext>
                  </a:extLst>
                </a:gridCol>
                <a:gridCol w="328434">
                  <a:extLst>
                    <a:ext uri="{9D8B030D-6E8A-4147-A177-3AD203B41FA5}">
                      <a16:colId xmlns:a16="http://schemas.microsoft.com/office/drawing/2014/main" val="259830447"/>
                    </a:ext>
                  </a:extLst>
                </a:gridCol>
                <a:gridCol w="684958">
                  <a:extLst>
                    <a:ext uri="{9D8B030D-6E8A-4147-A177-3AD203B41FA5}">
                      <a16:colId xmlns:a16="http://schemas.microsoft.com/office/drawing/2014/main" val="2639449095"/>
                    </a:ext>
                  </a:extLst>
                </a:gridCol>
                <a:gridCol w="679195">
                  <a:extLst>
                    <a:ext uri="{9D8B030D-6E8A-4147-A177-3AD203B41FA5}">
                      <a16:colId xmlns:a16="http://schemas.microsoft.com/office/drawing/2014/main" val="2013410189"/>
                    </a:ext>
                  </a:extLst>
                </a:gridCol>
                <a:gridCol w="522901">
                  <a:extLst>
                    <a:ext uri="{9D8B030D-6E8A-4147-A177-3AD203B41FA5}">
                      <a16:colId xmlns:a16="http://schemas.microsoft.com/office/drawing/2014/main" val="3770138334"/>
                    </a:ext>
                  </a:extLst>
                </a:gridCol>
                <a:gridCol w="579082">
                  <a:extLst>
                    <a:ext uri="{9D8B030D-6E8A-4147-A177-3AD203B41FA5}">
                      <a16:colId xmlns:a16="http://schemas.microsoft.com/office/drawing/2014/main" val="2154379098"/>
                    </a:ext>
                  </a:extLst>
                </a:gridCol>
                <a:gridCol w="562515">
                  <a:extLst>
                    <a:ext uri="{9D8B030D-6E8A-4147-A177-3AD203B41FA5}">
                      <a16:colId xmlns:a16="http://schemas.microsoft.com/office/drawing/2014/main" val="4199942382"/>
                    </a:ext>
                  </a:extLst>
                </a:gridCol>
                <a:gridCol w="424948">
                  <a:extLst>
                    <a:ext uri="{9D8B030D-6E8A-4147-A177-3AD203B41FA5}">
                      <a16:colId xmlns:a16="http://schemas.microsoft.com/office/drawing/2014/main" val="3125226619"/>
                    </a:ext>
                  </a:extLst>
                </a:gridCol>
                <a:gridCol w="638142">
                  <a:extLst>
                    <a:ext uri="{9D8B030D-6E8A-4147-A177-3AD203B41FA5}">
                      <a16:colId xmlns:a16="http://schemas.microsoft.com/office/drawing/2014/main" val="1163021515"/>
                    </a:ext>
                  </a:extLst>
                </a:gridCol>
                <a:gridCol w="504895">
                  <a:extLst>
                    <a:ext uri="{9D8B030D-6E8A-4147-A177-3AD203B41FA5}">
                      <a16:colId xmlns:a16="http://schemas.microsoft.com/office/drawing/2014/main" val="1219310560"/>
                    </a:ext>
                  </a:extLst>
                </a:gridCol>
                <a:gridCol w="612213">
                  <a:extLst>
                    <a:ext uri="{9D8B030D-6E8A-4147-A177-3AD203B41FA5}">
                      <a16:colId xmlns:a16="http://schemas.microsoft.com/office/drawing/2014/main" val="980092866"/>
                    </a:ext>
                  </a:extLst>
                </a:gridCol>
                <a:gridCol w="413423">
                  <a:extLst>
                    <a:ext uri="{9D8B030D-6E8A-4147-A177-3AD203B41FA5}">
                      <a16:colId xmlns:a16="http://schemas.microsoft.com/office/drawing/2014/main" val="2282664465"/>
                    </a:ext>
                  </a:extLst>
                </a:gridCol>
                <a:gridCol w="350041">
                  <a:extLst>
                    <a:ext uri="{9D8B030D-6E8A-4147-A177-3AD203B41FA5}">
                      <a16:colId xmlns:a16="http://schemas.microsoft.com/office/drawing/2014/main" val="3651253977"/>
                    </a:ext>
                  </a:extLst>
                </a:gridCol>
                <a:gridCol w="1511805">
                  <a:extLst>
                    <a:ext uri="{9D8B030D-6E8A-4147-A177-3AD203B41FA5}">
                      <a16:colId xmlns:a16="http://schemas.microsoft.com/office/drawing/2014/main" val="3718885992"/>
                    </a:ext>
                  </a:extLst>
                </a:gridCol>
              </a:tblGrid>
              <a:tr h="652863"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Patient ID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Age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Aetiolog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ECG indicatio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Device positio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Implan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Lead detail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Coil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Acces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LVSM at implant [</a:t>
                      </a:r>
                      <a:r>
                        <a:rPr lang="el-GR" sz="800" u="sng">
                          <a:effectLst/>
                        </a:rPr>
                        <a:t>Ω</a:t>
                      </a:r>
                      <a:r>
                        <a:rPr lang="en-GB" sz="800" u="sng">
                          <a:effectLst/>
                        </a:rPr>
                        <a:t>]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Rate of rise in LVSM [</a:t>
                      </a:r>
                      <a:r>
                        <a:rPr lang="el-GR" sz="800" u="sng">
                          <a:effectLst/>
                        </a:rPr>
                        <a:t>Ω</a:t>
                      </a:r>
                      <a:r>
                        <a:rPr lang="en-GB" sz="800" u="sng">
                          <a:effectLst/>
                        </a:rPr>
                        <a:t>/month]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LVSM prior to shock [</a:t>
                      </a:r>
                      <a:r>
                        <a:rPr lang="el-GR" sz="800" u="sng">
                          <a:effectLst/>
                        </a:rPr>
                        <a:t>Ω</a:t>
                      </a:r>
                      <a:r>
                        <a:rPr lang="en-GB" sz="800" u="sng">
                          <a:effectLst/>
                        </a:rPr>
                        <a:t>]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TSI</a:t>
                      </a:r>
                      <a:endParaRPr lang="en-GB" sz="1000">
                        <a:effectLst/>
                      </a:endParaRPr>
                    </a:p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[</a:t>
                      </a:r>
                      <a:r>
                        <a:rPr lang="el-GR" sz="800" u="sng">
                          <a:effectLst/>
                        </a:rPr>
                        <a:t>Ω</a:t>
                      </a:r>
                      <a:r>
                        <a:rPr lang="en-GB" sz="800" u="sng">
                          <a:effectLst/>
                        </a:rPr>
                        <a:t>]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u="sng">
                          <a:effectLst/>
                        </a:rPr>
                        <a:t>Managemen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812963500"/>
                  </a:ext>
                </a:extLst>
              </a:tr>
              <a:tr h="536452"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4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HC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Primary prevention, LBBB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ub-Pe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01/03/0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Guidant 018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Dual coi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ubclavia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58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6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67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16</a:t>
                      </a:r>
                      <a:endParaRPr lang="en-GB" sz="1000">
                        <a:effectLst/>
                      </a:endParaRPr>
                    </a:p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New RV lead added at time of upgrade to CRT. New LVSM 53</a:t>
                      </a:r>
                      <a:r>
                        <a:rPr lang="el-GR" sz="800">
                          <a:effectLst/>
                        </a:rPr>
                        <a:t> Ω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89820699"/>
                  </a:ext>
                </a:extLst>
              </a:tr>
              <a:tr h="377829"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2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HC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Primary prevention, Normal QR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ub-pe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20/12/1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Boston Scientific 029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ingle coi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Axillary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50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4.24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18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76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Continued monitorin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8590901"/>
                  </a:ext>
                </a:extLst>
              </a:tr>
              <a:tr h="322406"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38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HC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Primary prevention, LBBB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ub-Pe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8/07/0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Guidant 016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Dual coi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Cephali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38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2.93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26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78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Continued monitorin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918678427"/>
                  </a:ext>
                </a:extLst>
              </a:tr>
              <a:tr h="469507"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4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Long QT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econdary prevention, Normal QR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ub-Pe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Feb 201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Boston Scientific 069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ingle coi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dirty="0">
                          <a:effectLst/>
                        </a:rPr>
                        <a:t>Axillary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55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4.25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40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90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Attempted RV lead extraction and lead replacement, unable to retrieve RV coil. </a:t>
                      </a:r>
                      <a:r>
                        <a:rPr lang="en-GB" sz="800" u="sng">
                          <a:effectLst/>
                        </a:rPr>
                        <a:t> </a:t>
                      </a:r>
                      <a:r>
                        <a:rPr lang="en-GB" sz="800">
                          <a:effectLst/>
                        </a:rPr>
                        <a:t> New LVSM 54</a:t>
                      </a:r>
                      <a:r>
                        <a:rPr lang="el-GR" sz="800">
                          <a:effectLst/>
                        </a:rPr>
                        <a:t> Ω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884541346"/>
                  </a:ext>
                </a:extLst>
              </a:tr>
              <a:tr h="597545"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27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HCM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econdary prevention, RBBB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Sub-Pe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6/10/03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Guidant 016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Dual Coil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Cephali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55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.01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07 (DC)</a:t>
                      </a:r>
                      <a:endParaRPr lang="en-GB" sz="1000">
                        <a:effectLst/>
                      </a:endParaRPr>
                    </a:p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35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76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Continued monitoring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823557558"/>
                  </a:ext>
                </a:extLst>
              </a:tr>
              <a:tr h="377829"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6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32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Non-compaction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Primary prevention, Normal QRS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dirty="0">
                          <a:effectLst/>
                        </a:rPr>
                        <a:t>Sub-Cut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01/09/0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Guidant 0165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dirty="0">
                          <a:effectLst/>
                        </a:rPr>
                        <a:t>Dual coil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Cephalic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56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0.51 (D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37 (DC)</a:t>
                      </a:r>
                      <a:endParaRPr lang="en-GB" sz="1000">
                        <a:effectLst/>
                      </a:endParaRPr>
                    </a:p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54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>
                          <a:effectLst/>
                        </a:rPr>
                        <a:t>121 (SC)</a:t>
                      </a:r>
                      <a:endParaRPr lang="en-GB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6183" marR="16183" marT="16183" marB="0" anchor="ctr"/>
                </a:tc>
                <a:tc>
                  <a:txBody>
                    <a:bodyPr/>
                    <a:lstStyle/>
                    <a:p>
                      <a:pPr marL="47625" marR="47625" algn="ctr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812800" algn="l"/>
                        </a:tabLst>
                      </a:pPr>
                      <a:r>
                        <a:rPr lang="en-GB" sz="800" dirty="0">
                          <a:effectLst/>
                        </a:rPr>
                        <a:t>New RV lead added at time of box change.  New LVSM 52</a:t>
                      </a:r>
                      <a:r>
                        <a:rPr lang="el-GR" sz="800" dirty="0">
                          <a:effectLst/>
                        </a:rPr>
                        <a:t> Ω</a:t>
                      </a:r>
                      <a:endParaRPr lang="en-GB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20228296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 (</a:t>
            </a:r>
            <a:r>
              <a:rPr lang="en-GB" sz="2000" b="0" dirty="0"/>
              <a:t>Figure 1, RV lead impedance trends, *shock)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pic>
        <p:nvPicPr>
          <p:cNvPr id="8" name="Content Placeholder 7" descr="A picture containing text&#10;&#10;Description automatically generated">
            <a:extLst>
              <a:ext uri="{FF2B5EF4-FFF2-40B4-BE49-F238E27FC236}">
                <a16:creationId xmlns:a16="http://schemas.microsoft.com/office/drawing/2014/main" id="{F6734FBB-3D63-4AF5-987F-C5D687CEBEA2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1316" y="1063625"/>
            <a:ext cx="5393296" cy="3439003"/>
          </a:xfrm>
        </p:spPr>
      </p:pic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 (</a:t>
            </a:r>
            <a:r>
              <a:rPr lang="en-GB" sz="2000" b="0" dirty="0"/>
              <a:t>Figure 2, PA chest radiographs</a:t>
            </a:r>
            <a:r>
              <a:rPr lang="en-GB" sz="2200" b="0" dirty="0"/>
              <a:t>)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pic>
        <p:nvPicPr>
          <p:cNvPr id="10" name="Content Placeholder 9" descr="A picture containing photo&#10;&#10;Description automatically generated">
            <a:extLst>
              <a:ext uri="{FF2B5EF4-FFF2-40B4-BE49-F238E27FC236}">
                <a16:creationId xmlns:a16="http://schemas.microsoft.com/office/drawing/2014/main" id="{98A7AE26-025D-46BA-984C-87D5E67052A3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4795" y="1063625"/>
            <a:ext cx="4834410" cy="3481200"/>
          </a:xfrm>
        </p:spPr>
      </p:pic>
    </p:spTree>
    <p:extLst>
      <p:ext uri="{BB962C8B-B14F-4D97-AF65-F5344CB8AC3E}">
        <p14:creationId xmlns:p14="http://schemas.microsoft.com/office/powerpoint/2010/main" val="1866326171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11" name="Title 2">
            <a:extLst>
              <a:ext uri="{FF2B5EF4-FFF2-40B4-BE49-F238E27FC236}">
                <a16:creationId xmlns:a16="http://schemas.microsoft.com/office/drawing/2014/main" id="{B15732B7-8425-49DE-BEE1-E7534D00C4B4}"/>
              </a:ext>
            </a:extLst>
          </p:cNvPr>
          <p:cNvSpPr txBox="1">
            <a:spLocks/>
          </p:cNvSpPr>
          <p:nvPr/>
        </p:nvSpPr>
        <p:spPr>
          <a:xfrm>
            <a:off x="740905" y="942368"/>
            <a:ext cx="7326649" cy="727075"/>
          </a:xfrm>
          <a:prstGeom prst="rect">
            <a:avLst/>
          </a:prstGeom>
        </p:spPr>
        <p:txBody>
          <a:bodyPr vert="horz" lIns="0" tIns="45720" rIns="0" bIns="45720" rtlCol="0" anchor="ctr"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000" u="sng" dirty="0"/>
              <a:t>True shock impedance (TSI) Vs low-voltage sub-threshold (LVSM) measurement</a:t>
            </a:r>
          </a:p>
        </p:txBody>
      </p:sp>
      <p:sp>
        <p:nvSpPr>
          <p:cNvPr id="12" name="Text Placeholder 5">
            <a:extLst>
              <a:ext uri="{FF2B5EF4-FFF2-40B4-BE49-F238E27FC236}">
                <a16:creationId xmlns:a16="http://schemas.microsoft.com/office/drawing/2014/main" id="{D0678C51-D809-4D85-ADFA-28CC6489903E}"/>
              </a:ext>
            </a:extLst>
          </p:cNvPr>
          <p:cNvSpPr txBox="1">
            <a:spLocks/>
          </p:cNvSpPr>
          <p:nvPr/>
        </p:nvSpPr>
        <p:spPr>
          <a:xfrm>
            <a:off x="740905" y="1732158"/>
            <a:ext cx="7326649" cy="1679183"/>
          </a:xfrm>
          <a:prstGeom prst="rect">
            <a:avLst/>
          </a:prstGeom>
        </p:spPr>
        <p:txBody>
          <a:bodyPr numCol="2"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TSI needs a full output shock to determine impedance. </a:t>
            </a:r>
          </a:p>
          <a:p>
            <a:endParaRPr lang="en-GB" dirty="0"/>
          </a:p>
          <a:p>
            <a:endParaRPr lang="en-GB" dirty="0"/>
          </a:p>
          <a:p>
            <a:endParaRPr lang="en-GB" dirty="0"/>
          </a:p>
          <a:p>
            <a:r>
              <a:rPr lang="en-GB" dirty="0"/>
              <a:t>LVSM use a small electrical impulse of 80µA@ 156µs to measure the impedance</a:t>
            </a:r>
            <a:r>
              <a:rPr lang="en-GB" baseline="30000" dirty="0"/>
              <a:t>1</a:t>
            </a:r>
            <a:r>
              <a:rPr lang="en-GB" dirty="0"/>
              <a:t>. (Boston value, SJM and </a:t>
            </a:r>
            <a:r>
              <a:rPr lang="en-GB" dirty="0" err="1"/>
              <a:t>Biotronik</a:t>
            </a:r>
            <a:r>
              <a:rPr lang="en-GB" dirty="0"/>
              <a:t> are similar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E248C1F-B513-46FD-B9CE-6D544ECA809E}"/>
              </a:ext>
            </a:extLst>
          </p:cNvPr>
          <p:cNvSpPr txBox="1"/>
          <p:nvPr/>
        </p:nvSpPr>
        <p:spPr>
          <a:xfrm>
            <a:off x="740905" y="3474056"/>
            <a:ext cx="743149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Smaller currents are affected by small changes in impedance from external and internal factors. Fluctuations day to day show external factors. </a:t>
            </a: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925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dirty="0"/>
              <a:t>Encapsulation </a:t>
            </a:r>
            <a:r>
              <a:rPr lang="en-GB" b="0" dirty="0"/>
              <a:t>may cause the LVSM to be high, as a small, gradual increase in resistance with rising tissue density surrounding the coil is scaled to produce a falsely high LVSM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All patients had </a:t>
            </a:r>
            <a:r>
              <a:rPr lang="en-GB" dirty="0"/>
              <a:t>GORE </a:t>
            </a:r>
            <a:r>
              <a:rPr lang="en-GB" dirty="0" err="1"/>
              <a:t>ePTFE</a:t>
            </a:r>
            <a:r>
              <a:rPr lang="en-GB" dirty="0"/>
              <a:t> </a:t>
            </a:r>
            <a:r>
              <a:rPr lang="en-GB" b="0" dirty="0"/>
              <a:t>coated coils. When GORE </a:t>
            </a:r>
            <a:r>
              <a:rPr lang="en-GB" b="0" dirty="0" err="1"/>
              <a:t>ePTFE</a:t>
            </a:r>
            <a:r>
              <a:rPr lang="en-GB" b="0" dirty="0"/>
              <a:t> coated coils were produced there was a warning that one may expose the coil by damaging the coating if not implanted correctly</a:t>
            </a:r>
            <a:r>
              <a:rPr lang="en-GB" b="0" baseline="30000" dirty="0"/>
              <a:t>2</a:t>
            </a:r>
            <a:r>
              <a:rPr lang="en-GB" b="0" dirty="0"/>
              <a:t>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Another theory is </a:t>
            </a:r>
            <a:r>
              <a:rPr lang="en-GB" dirty="0"/>
              <a:t>ionic build up </a:t>
            </a:r>
            <a:r>
              <a:rPr lang="en-GB" b="0" dirty="0"/>
              <a:t>around the RV coil. Ionic build up that dissipates with synchronised shock may prove a reason as to why the LVSM transiently drops post shock, before increasing once more.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14FC9F3-A5BE-4A92-AAAE-56349888BA3D}"/>
              </a:ext>
            </a:extLst>
          </p:cNvPr>
          <p:cNvSpPr txBox="1"/>
          <p:nvPr/>
        </p:nvSpPr>
        <p:spPr>
          <a:xfrm rot="10800000" flipV="1">
            <a:off x="969670" y="1475570"/>
            <a:ext cx="6552727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 </a:t>
            </a:r>
            <a:r>
              <a:rPr lang="en-GB" b="1" dirty="0"/>
              <a:t>full clinical assessment </a:t>
            </a:r>
            <a:r>
              <a:rPr lang="en-GB" dirty="0"/>
              <a:t>is necessary the investigative the cause for rise in impedance. One may predict such an issue, however, from just six cases there is insufficient data to produce this. </a:t>
            </a:r>
          </a:p>
          <a:p>
            <a:endParaRPr lang="en-GB" dirty="0"/>
          </a:p>
          <a:p>
            <a:r>
              <a:rPr lang="en-GB" dirty="0"/>
              <a:t>If patients are to be considered for  </a:t>
            </a:r>
            <a:r>
              <a:rPr lang="en-GB" b="1" dirty="0"/>
              <a:t>lead extraction</a:t>
            </a:r>
            <a:r>
              <a:rPr lang="en-GB" dirty="0"/>
              <a:t>, this may be a </a:t>
            </a:r>
            <a:r>
              <a:rPr lang="en-GB" b="1" dirty="0"/>
              <a:t>higher risk</a:t>
            </a:r>
            <a:r>
              <a:rPr lang="en-GB" dirty="0"/>
              <a:t> procedure.</a:t>
            </a:r>
          </a:p>
          <a:p>
            <a:endParaRPr lang="en-GB" dirty="0"/>
          </a:p>
          <a:p>
            <a:r>
              <a:rPr lang="en-GB" dirty="0"/>
              <a:t>A suggested </a:t>
            </a:r>
            <a:r>
              <a:rPr lang="en-GB" b="1" dirty="0"/>
              <a:t>management flow diagram</a:t>
            </a:r>
            <a:r>
              <a:rPr lang="en-GB" dirty="0"/>
              <a:t> is demonstrated on the next slide.</a:t>
            </a: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Figure 3">
            <a:extLst>
              <a:ext uri="{FF2B5EF4-FFF2-40B4-BE49-F238E27FC236}">
                <a16:creationId xmlns:a16="http://schemas.microsoft.com/office/drawing/2014/main" id="{BC807D21-2EE9-4C30-AF64-56B639841335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7" t="1187" r="15905" b="3116"/>
          <a:stretch/>
        </p:blipFill>
        <p:spPr>
          <a:xfrm>
            <a:off x="892800" y="0"/>
            <a:ext cx="4903200" cy="4622399"/>
          </a:xfrm>
          <a:ln>
            <a:noFill/>
          </a:ln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9904" y="337325"/>
            <a:ext cx="6552728" cy="857250"/>
          </a:xfrm>
        </p:spPr>
        <p:txBody>
          <a:bodyPr anchor="t">
            <a:normAutofit/>
          </a:bodyPr>
          <a:lstStyle/>
          <a:p>
            <a:r>
              <a:rPr lang="en-GB" b="0" dirty="0"/>
              <a:t>Management flow chart</a:t>
            </a:r>
            <a:endParaRPr lang="en-GB" sz="16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C8FAC7-7E94-498F-9F5A-01EE4E1E3A7C}"/>
              </a:ext>
            </a:extLst>
          </p:cNvPr>
          <p:cNvSpPr txBox="1"/>
          <p:nvPr/>
        </p:nvSpPr>
        <p:spPr>
          <a:xfrm>
            <a:off x="7178533" y="3730277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3</a:t>
            </a:r>
          </a:p>
        </p:txBody>
      </p:sp>
    </p:spTree>
    <p:extLst>
      <p:ext uri="{BB962C8B-B14F-4D97-AF65-F5344CB8AC3E}">
        <p14:creationId xmlns:p14="http://schemas.microsoft.com/office/powerpoint/2010/main" val="2622969113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0</TotalTime>
  <Words>862</Words>
  <Application>Microsoft Office PowerPoint</Application>
  <PresentationFormat>On-screen Show (16:9)</PresentationFormat>
  <Paragraphs>158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1</vt:i4>
      </vt:variant>
    </vt:vector>
  </HeadingPairs>
  <TitlesOfParts>
    <vt:vector size="18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High voltage impedance rise; mechanism and management in patients with transvenous implantable cardioverter defibrillators. A case series.</vt:lpstr>
      <vt:lpstr>Introduction</vt:lpstr>
      <vt:lpstr>Case Presentations Summary Table History and Examination Findings</vt:lpstr>
      <vt:lpstr>Case Presentation Investigations (Figure 1, RV lead impedance trends, *shock)</vt:lpstr>
      <vt:lpstr>Case Presentation Investigations (Figure 2, PA chest radiographs)</vt:lpstr>
      <vt:lpstr>Discussion </vt:lpstr>
      <vt:lpstr>Discussion</vt:lpstr>
      <vt:lpstr>Case Presentation Management</vt:lpstr>
      <vt:lpstr>Management flow chart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Christopher Monkhouse</cp:lastModifiedBy>
  <cp:revision>47</cp:revision>
  <dcterms:created xsi:type="dcterms:W3CDTF">2017-10-02T09:19:02Z</dcterms:created>
  <dcterms:modified xsi:type="dcterms:W3CDTF">2019-10-30T07:25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